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CB868-6B1A-4A24-B6F1-2C6A95BF5C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29C59-507F-4D8F-85C5-04486340C7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86217-7711-4663-BA0A-7C78A17521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E795D-BD65-4B05-8469-53038EEF03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B269E7-DF16-40F2-9BCF-AAFB33DA6B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DA623-E5D7-49A2-BAEB-0AAC1F0321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A45B31-C953-49E7-BD54-EE50DE9E3E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39CF0-BD6C-464F-A182-C2DD6811C6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D7641-6B10-4F68-BA4A-4ED0CEF86B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B3E51-828B-4B34-BE6E-67B38FB3B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168D6-CDC3-4233-A3B0-8A8F8DE190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22CDC-4CEF-4DBE-A032-C538CC4551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EE9077-FB73-4AD6-86BB-C6DFBFDD760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77920" y="15778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65120" y="316224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57200" y="66348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rcRect l="-372" t="0" r="-1290" b="-1260"/>
          <a:stretch/>
        </p:blipFill>
        <p:spPr>
          <a:xfrm>
            <a:off x="1260360" y="0"/>
            <a:ext cx="4378320" cy="63244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1311120" y="6248520"/>
            <a:ext cx="4267440" cy="25984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228600" y="8847000"/>
            <a:ext cx="6324480" cy="105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3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condary structure predicted for the six LGR proteins (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aligned secondary structure prediction of LgrA and LgrE (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The prediction of the secondary structure was performed using NNPREDICT [47 , 48]. The position of the LRRs determined by the CAS analysis (Additional File 6) is indicated by vertical lines. The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helix/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heet of the consensus LRRs are determined if at least 50%/15% of the amino acids of the repeats present at this relative position of the LRRs of the protein were involved in an 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helix/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sheet as documented on the Additional File 7. This figure validates our CAS analysis: no secondary structure is present at boundaries between LRRs and no LRR as defined by this secondary analysis were ignored by our non a priori approach.</a:t>
            </a:r>
            <a:r>
              <a:rPr b="0" lang="fr-FR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22:55Z</dcterms:created>
  <dc:creator>Gilbert Greub</dc:creator>
  <dc:description/>
  <dc:language>en-US</dc:language>
  <cp:lastModifiedBy>CA Roten</cp:lastModifiedBy>
  <dcterms:modified xsi:type="dcterms:W3CDTF">2007-11-14T13:59:07Z</dcterms:modified>
  <cp:revision>10</cp:revision>
  <dc:subject/>
  <dc:title>Présentation PowerPoint</dc:title>
</cp:coreProperties>
</file>